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05E216-6B51-4F68-951C-6A20B0320F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E5557-2307-40D9-8705-ED5BCCFDC2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50852-4F2B-43F8-9344-F70504B4C8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BBE488-99E3-4215-A2D1-6A964839F1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12989-2989-4102-8CB4-E19EC23A35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60992F-310C-455C-B367-8C89518157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FE1CE9-B116-4508-92C3-77E2BF4AE4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9AF449-E408-4CD9-9929-D1CA0A88FE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0C368-FF12-4828-8CE1-9544BA94A6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DC10E-AEF6-422F-829F-658340BCFA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B3CC6-AEE1-4863-BF6C-459C29A1BC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A8D3FC-BE45-4357-9659-30C386AE6F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DD6535-E030-4191-9395-E5E97B46CB5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CAPAN1_aCGH"/>
          <p:cNvPicPr/>
          <p:nvPr/>
        </p:nvPicPr>
        <p:blipFill>
          <a:blip r:embed="rId1"/>
          <a:srcRect l="0" t="8641" r="0" b="2467"/>
          <a:stretch/>
        </p:blipFill>
        <p:spPr>
          <a:xfrm>
            <a:off x="0" y="1219320"/>
            <a:ext cx="9144000" cy="5486400"/>
          </a:xfrm>
          <a:prstGeom prst="rect">
            <a:avLst/>
          </a:prstGeom>
          <a:ln w="0">
            <a:noFill/>
          </a:ln>
        </p:spPr>
      </p:pic>
      <p:sp>
        <p:nvSpPr>
          <p:cNvPr id="42" name="Line 5"/>
          <p:cNvSpPr/>
          <p:nvPr/>
        </p:nvSpPr>
        <p:spPr>
          <a:xfrm>
            <a:off x="152280" y="3487680"/>
            <a:ext cx="899172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6"/>
          <p:cNvSpPr/>
          <p:nvPr/>
        </p:nvSpPr>
        <p:spPr>
          <a:xfrm>
            <a:off x="152280" y="3979800"/>
            <a:ext cx="899172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7"/>
          <p:cNvSpPr/>
          <p:nvPr/>
        </p:nvSpPr>
        <p:spPr>
          <a:xfrm>
            <a:off x="152280" y="3166920"/>
            <a:ext cx="8991720" cy="0"/>
          </a:xfrm>
          <a:prstGeom prst="line">
            <a:avLst/>
          </a:prstGeom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8"/>
          <p:cNvSpPr/>
          <p:nvPr/>
        </p:nvSpPr>
        <p:spPr>
          <a:xfrm>
            <a:off x="152280" y="2938320"/>
            <a:ext cx="8991720" cy="0"/>
          </a:xfrm>
          <a:prstGeom prst="line">
            <a:avLst/>
          </a:prstGeom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9"/>
          <p:cNvSpPr/>
          <p:nvPr/>
        </p:nvSpPr>
        <p:spPr>
          <a:xfrm>
            <a:off x="152280" y="2666880"/>
            <a:ext cx="8991720" cy="0"/>
          </a:xfrm>
          <a:prstGeom prst="line">
            <a:avLst/>
          </a:prstGeom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Footer Placeholder 79"/>
          <p:cNvSpPr/>
          <p:nvPr/>
        </p:nvSpPr>
        <p:spPr>
          <a:xfrm>
            <a:off x="7927920" y="0"/>
            <a:ext cx="1216080" cy="41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arber et a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Footer Placeholder 79"/>
          <p:cNvSpPr/>
          <p:nvPr/>
        </p:nvSpPr>
        <p:spPr>
          <a:xfrm>
            <a:off x="0" y="76320"/>
            <a:ext cx="6705720" cy="99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: aCGH data for CAPAN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py number status were calculated based on aCGH data. Haploid regions were estimated to present a log2 value between -1 and -0.45, diploid regions a log2 value between -0.45 and 0.05, triploid regions a log2 value ~0.05-0.30 and tetraploid regions a log2 value of ~0.30-0.55. Regions with values greater than 0.55 were considered pentaploid for filtering purpos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Footer Placeholder 79"/>
          <p:cNvSpPr/>
          <p:nvPr/>
        </p:nvSpPr>
        <p:spPr>
          <a:xfrm>
            <a:off x="3963960" y="6553080"/>
            <a:ext cx="12160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romosom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Footer Placeholder 79"/>
          <p:cNvSpPr/>
          <p:nvPr/>
        </p:nvSpPr>
        <p:spPr>
          <a:xfrm rot="16200000">
            <a:off x="-123480" y="1342800"/>
            <a:ext cx="814320" cy="41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og rati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7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5T15:43:55Z</dcterms:created>
  <dc:creator>Louise</dc:creator>
  <dc:description/>
  <dc:language>en-US</dc:language>
  <cp:lastModifiedBy>Rob Hall</cp:lastModifiedBy>
  <dcterms:modified xsi:type="dcterms:W3CDTF">2011-06-15T15:55:59Z</dcterms:modified>
  <cp:revision>4</cp:revision>
  <dc:subject/>
  <dc:title>PowerPoint Presentation</dc:title>
</cp:coreProperties>
</file>